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D2EBC-DE0F-4306-83A6-BAF9AB33A3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DDA4C-D011-42EE-9E31-2909653CEF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B9848-4026-45B7-BBAB-5B7D01F3EA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31417-40A8-4B8E-80EF-2A82C9B221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A7AB5-BA70-493F-B942-077C8FEEA1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9F6C4-B6BE-45D6-88CA-76B478D1A9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4AB74-D2F0-4199-989D-B857BDC954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95A97-6954-420D-BFB0-1CA87F373E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86840-357C-4035-8AA7-9629CAA11A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BD052-9D4F-4E36-B628-98D6B78D4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0FA0D-741F-4C26-B0B6-628493FE76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1767C7-E9FE-4C6A-9DBE-8F6047CCA4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087F43-FFA2-4D73-AFFC-B669211CA80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flipV="1">
            <a:off x="2133720" y="22824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/>
          </p:nvPr>
        </p:nvSpPr>
        <p:spPr>
          <a:xfrm>
            <a:off x="685800" y="75960"/>
            <a:ext cx="7772400" cy="6629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   CCTCTCTCGG  CTAGACGAGC  TTCCCCAACT  GGTAACCCTT  CCACACCCCA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1" lang="en-GB" sz="1000" spc="-1" strike="noStrike" baseline="-30000">
                <a:solidFill>
                  <a:srgbClr val="000000"/>
                </a:solidFill>
                <a:latin typeface="Times New Roman"/>
                <a:ea typeface="Times New Roman"/>
              </a:rPr>
              <a:t>1                                                                                                           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1" lang="en-GB" sz="1000" spc="-1" strike="noStrike" baseline="-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1   ATCTTCATGG  ACCAGAGATC  TTGGATGTTC  CTTCCACAGT  TCAAAAGAC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1 CCTTTCGTCA  CCCACCCTGG  GTATGACACT  GGAAATGGTA TTCAGCTTC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1 TGGCACTTCT  GGTCAGCAAC  CCAGTGTTGG  GCAACAAATG  ATCTTTGAGG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1 AACATGGTTT  TAGGCGGACC  ACACCGCCCA  CAACGGCCAC  CCCCATAAGG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                               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1" lang="en-GB" sz="1000" spc="-1" strike="noStrike" baseline="-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1 CATAGGCCAA  GACCATACCC  GCCGAATGTA  G</a:t>
            </a:r>
            <a:r>
              <a:rPr b="1" lang="en-GB" sz="10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GTGAGGAAA  TCCAAATTGG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1 </a:t>
            </a:r>
            <a:r>
              <a:rPr b="1" lang="en-GB" sz="10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TCACATTCCC   AGGGAAGATG  TAGACTATCA  CCTGTACCCA  CACGGTCCGG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1" lang="en-GB" sz="1000" spc="-1" strike="noStrike" baseline="-30000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1 </a:t>
            </a:r>
            <a:r>
              <a:rPr b="1" lang="en-GB" sz="10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GACTCAATCC  AAATGCCTCT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1" lang="en-GB" sz="10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ACAG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CAAG  AAGCTCTCTC  TCAGACAAC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1 ATCTCATGGG  CCCCATTCCA  GGACACTTCT  GAGTACATCA  TTTCATGTCA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                                        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1" lang="en-GB" sz="1000" spc="-1" strike="noStrike" baseline="-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51 TCCTGTTGGC  ACTGATGAAG  AACCCTTACA  GGTAATTAAT  TGTTCTCTT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1 ACTTCTCATG  GGGCAGCACA  GAAAGGAATA  AGTTAGGTAA  CTGAAGTGA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51 CAGCCCTCGA  ATAAAAAGTG  GCTTCATGGC  CGGGTGTGAT  GGCTCACGC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1 TGTAATCCCA  GCACTTTGGG  AGGCCGAGGC  AGGTGGATCA  TTTGAGGTTA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51 GGAGTTCAAG  ACCAGCCTGG  CCAACATGGT  GAAACCTCGT   CTCTTGAAAA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01 AAAAAAAAAA  AAAGTGGCTC  CACCTTTTAG  AACCTCTTAG  AAGATGGCA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51 ATTTAAGCCC  TGCTTTTTTT  TTTTTTTAAA  TCCCAATATG  GCTCTACTTT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1 GGAGGACATA  CCAGAGAGTC  ACTAGCCTTT  TATTTCCATA  GAGAAAATGA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51 AACTATTTCT   CTTATTCTCA   CACATTTGAG  GTTCCTTTTT  GAGTAAGATA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1 GATGGTTCTA  GAAAAGAAAG  AAAGATATTC  TACCTGAATT  TCCATTTGTG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51 TGCAGAAGTC  TAAAACACTA  CCTTTACGAT  TTGTCCTTGA  AGAACCCCAC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85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1 TATCTACAAC ATATCTAAAG  AAAAAAAAAA  ACAGCGAAGC  TGTGCATAGC AG 105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 marL="585000" indent="0" algn="just">
              <a:lnSpc>
                <a:spcPct val="9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 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724280" y="30492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114800" y="152388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276720" y="220968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038480" y="281952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8-21T06:09:13Z</dcterms:created>
  <dc:creator>Uwe Trefzer</dc:creator>
  <dc:description/>
  <dc:language>en-US</dc:language>
  <cp:lastModifiedBy>MDE-LAB-A1</cp:lastModifiedBy>
  <dcterms:modified xsi:type="dcterms:W3CDTF">2005-08-28T16:40:00Z</dcterms:modified>
  <cp:revision>2</cp:revision>
  <dc:subject/>
  <dc:title>PowerPoint-Präsentation</dc:title>
</cp:coreProperties>
</file>